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58" userDrawn="1">
          <p15:clr>
            <a:srgbClr val="A4A3A4"/>
          </p15:clr>
        </p15:guide>
        <p15:guide id="2" pos="4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40" d="100"/>
          <a:sy n="140" d="100"/>
        </p:scale>
        <p:origin x="948" y="126"/>
      </p:cViewPr>
      <p:guideLst>
        <p:guide orient="horz" pos="958"/>
        <p:guide pos="4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c vs o wet weight'!$V$3</c:f>
              <c:strCache>
                <c:ptCount val="1"/>
                <c:pt idx="0">
                  <c:v>Organic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wet weight'!$U$4:$U$18</c:f>
              <c:strCache>
                <c:ptCount val="15"/>
                <c:pt idx="0">
                  <c:v>Composite dishes, n=21</c:v>
                </c:pt>
                <c:pt idx="1">
                  <c:v>Products for non-standard diets and food imitates (tofu)</c:v>
                </c:pt>
                <c:pt idx="2">
                  <c:v>Food products for infants and toddlers, n=4</c:v>
                </c:pt>
                <c:pt idx="3">
                  <c:v>Alcoholic beverages, n=3</c:v>
                </c:pt>
                <c:pt idx="4">
                  <c:v>Coffee, cocoa, tea and infusions, n=2</c:v>
                </c:pt>
                <c:pt idx="5">
                  <c:v>Animal and vegetable fats and oils, n=4</c:v>
                </c:pt>
                <c:pt idx="6">
                  <c:v>Sugar, confectionery and water-based sweet desserts, n=2</c:v>
                </c:pt>
                <c:pt idx="7">
                  <c:v>Eggs and egg products, n=2</c:v>
                </c:pt>
                <c:pt idx="8">
                  <c:v>Milk and dairy products, n=7</c:v>
                </c:pt>
                <c:pt idx="9">
                  <c:v>Meat and meat products, n=12</c:v>
                </c:pt>
                <c:pt idx="10">
                  <c:v>Fruit and fruit products, n=2</c:v>
                </c:pt>
                <c:pt idx="11">
                  <c:v>Legumes, nuts, oilseeds and spices, n=4</c:v>
                </c:pt>
                <c:pt idx="12">
                  <c:v>Starchy roots or tubers and products thereof, n=2</c:v>
                </c:pt>
                <c:pt idx="13">
                  <c:v>Vegetables and vegetable products, n=7</c:v>
                </c:pt>
                <c:pt idx="14">
                  <c:v>Grains and grain-based products, n=14</c:v>
                </c:pt>
              </c:strCache>
            </c:strRef>
          </c:cat>
          <c:val>
            <c:numRef>
              <c:f>'c vs o wet weight'!$V$4:$V$18</c:f>
              <c:numCache>
                <c:formatCode>0.000</c:formatCode>
                <c:ptCount val="15"/>
                <c:pt idx="0">
                  <c:v>7.8340079365079376E-2</c:v>
                </c:pt>
                <c:pt idx="1">
                  <c:v>9.1999999999999998E-3</c:v>
                </c:pt>
                <c:pt idx="2">
                  <c:v>3.1447500000000003E-2</c:v>
                </c:pt>
                <c:pt idx="3">
                  <c:v>2.6999999999999997E-3</c:v>
                </c:pt>
                <c:pt idx="4">
                  <c:v>2.0200000000000001E-3</c:v>
                </c:pt>
                <c:pt idx="5">
                  <c:v>0.36231705882352944</c:v>
                </c:pt>
                <c:pt idx="6">
                  <c:v>0.12115000000000001</c:v>
                </c:pt>
                <c:pt idx="7">
                  <c:v>7.7589311119837051E-2</c:v>
                </c:pt>
                <c:pt idx="8">
                  <c:v>0.16031168637915877</c:v>
                </c:pt>
                <c:pt idx="9">
                  <c:v>0.2508645303291574</c:v>
                </c:pt>
                <c:pt idx="10">
                  <c:v>6.2000000000000006E-3</c:v>
                </c:pt>
                <c:pt idx="11">
                  <c:v>5.5099999999999996E-2</c:v>
                </c:pt>
                <c:pt idx="12">
                  <c:v>3.0574999999999998E-2</c:v>
                </c:pt>
                <c:pt idx="13">
                  <c:v>1.7121428571428572E-2</c:v>
                </c:pt>
                <c:pt idx="14">
                  <c:v>3.06134714285714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77-4365-979A-A084E3A16BFA}"/>
            </c:ext>
          </c:extLst>
        </c:ser>
        <c:ser>
          <c:idx val="1"/>
          <c:order val="1"/>
          <c:tx>
            <c:strRef>
              <c:f>'c vs o wet weight'!$W$3</c:f>
              <c:strCache>
                <c:ptCount val="1"/>
                <c:pt idx="0">
                  <c:v>Conventiona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10"/>
              <c:numFmt formatCode="#,##0.0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F977-4365-979A-A084E3A16BF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wet weight'!$U$4:$U$18</c:f>
              <c:strCache>
                <c:ptCount val="15"/>
                <c:pt idx="0">
                  <c:v>Composite dishes, n=21</c:v>
                </c:pt>
                <c:pt idx="1">
                  <c:v>Products for non-standard diets and food imitates (tofu)</c:v>
                </c:pt>
                <c:pt idx="2">
                  <c:v>Food products for infants and toddlers, n=4</c:v>
                </c:pt>
                <c:pt idx="3">
                  <c:v>Alcoholic beverages, n=3</c:v>
                </c:pt>
                <c:pt idx="4">
                  <c:v>Coffee, cocoa, tea and infusions, n=2</c:v>
                </c:pt>
                <c:pt idx="5">
                  <c:v>Animal and vegetable fats and oils, n=4</c:v>
                </c:pt>
                <c:pt idx="6">
                  <c:v>Sugar, confectionery and water-based sweet desserts, n=2</c:v>
                </c:pt>
                <c:pt idx="7">
                  <c:v>Eggs and egg products, n=2</c:v>
                </c:pt>
                <c:pt idx="8">
                  <c:v>Milk and dairy products, n=7</c:v>
                </c:pt>
                <c:pt idx="9">
                  <c:v>Meat and meat products, n=12</c:v>
                </c:pt>
                <c:pt idx="10">
                  <c:v>Fruit and fruit products, n=2</c:v>
                </c:pt>
                <c:pt idx="11">
                  <c:v>Legumes, nuts, oilseeds and spices, n=4</c:v>
                </c:pt>
                <c:pt idx="12">
                  <c:v>Starchy roots or tubers and products thereof, n=2</c:v>
                </c:pt>
                <c:pt idx="13">
                  <c:v>Vegetables and vegetable products, n=7</c:v>
                </c:pt>
                <c:pt idx="14">
                  <c:v>Grains and grain-based products, n=14</c:v>
                </c:pt>
              </c:strCache>
            </c:strRef>
          </c:cat>
          <c:val>
            <c:numRef>
              <c:f>'c vs o wet weight'!$W$4:$W$18</c:f>
              <c:numCache>
                <c:formatCode>0.000</c:formatCode>
                <c:ptCount val="15"/>
                <c:pt idx="0">
                  <c:v>5.6529861111111114E-2</c:v>
                </c:pt>
                <c:pt idx="1">
                  <c:v>6.0000000000000001E-3</c:v>
                </c:pt>
                <c:pt idx="2">
                  <c:v>1.48275E-2</c:v>
                </c:pt>
                <c:pt idx="3">
                  <c:v>4.7333333333333333E-3</c:v>
                </c:pt>
                <c:pt idx="4">
                  <c:v>2.875E-3</c:v>
                </c:pt>
                <c:pt idx="5">
                  <c:v>0.27567895316723467</c:v>
                </c:pt>
                <c:pt idx="6">
                  <c:v>7.2250000000000009E-2</c:v>
                </c:pt>
                <c:pt idx="7">
                  <c:v>7.8853600714696825E-2</c:v>
                </c:pt>
                <c:pt idx="8">
                  <c:v>0.16248885363384893</c:v>
                </c:pt>
                <c:pt idx="9">
                  <c:v>9.765155158482948E-2</c:v>
                </c:pt>
                <c:pt idx="10">
                  <c:v>7.5500000000000003E-3</c:v>
                </c:pt>
                <c:pt idx="11">
                  <c:v>7.4937500000000004E-2</c:v>
                </c:pt>
                <c:pt idx="12">
                  <c:v>0.11600000000000001</c:v>
                </c:pt>
                <c:pt idx="13">
                  <c:v>2.9864285714285711E-2</c:v>
                </c:pt>
                <c:pt idx="14">
                  <c:v>1.858137142857143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977-4365-979A-A084E3A16B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80712272"/>
        <c:axId val="680716864"/>
      </c:barChart>
      <c:catAx>
        <c:axId val="680712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6864"/>
        <c:crosses val="autoZero"/>
        <c:auto val="1"/>
        <c:lblAlgn val="ctr"/>
        <c:lblOffset val="100"/>
        <c:noMultiLvlLbl val="0"/>
      </c:catAx>
      <c:valAx>
        <c:axId val="6807168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UB 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vels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∑6 NDL-PCBs (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g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</a:t>
                </a:r>
                <a:r>
                  <a:rPr lang="de-DE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t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de-DE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9866183472462833"/>
              <c:y val="0.935048823159526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2272"/>
        <c:crosses val="autoZero"/>
        <c:crossBetween val="between"/>
        <c:majorUnit val="5.000000000000001E-2"/>
      </c:valAx>
    </c:plotArea>
    <c:legend>
      <c:legendPos val="r"/>
      <c:layout>
        <c:manualLayout>
          <c:xMode val="edge"/>
          <c:yMode val="edge"/>
          <c:x val="0.76631739971188095"/>
          <c:y val="3.6059472051843844E-2"/>
          <c:w val="0.12501233044080876"/>
          <c:h val="0.1186940874939465"/>
        </c:manualLayout>
      </c:layout>
      <c:overlay val="0"/>
      <c:txPr>
        <a:bodyPr/>
        <a:lstStyle/>
        <a:p>
          <a:pPr>
            <a:defRPr sz="800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c vs o fat'!$E$26</c:f>
              <c:strCache>
                <c:ptCount val="1"/>
                <c:pt idx="0">
                  <c:v>Organic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6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0-C2A6-4871-90DC-67E2ED992F49}"/>
                </c:ext>
              </c:extLst>
            </c:dLbl>
            <c:dLbl>
              <c:idx val="7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C2A6-4871-90DC-67E2ED992F49}"/>
                </c:ext>
              </c:extLst>
            </c:dLbl>
            <c:dLbl>
              <c:idx val="8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2-C2A6-4871-90DC-67E2ED992F49}"/>
                </c:ext>
              </c:extLst>
            </c:dLbl>
            <c:dLbl>
              <c:idx val="9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C2A6-4871-90DC-67E2ED992F49}"/>
                </c:ext>
              </c:extLst>
            </c:dLbl>
            <c:dLbl>
              <c:idx val="10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4-C2A6-4871-90DC-67E2ED992F49}"/>
                </c:ext>
              </c:extLst>
            </c:dLbl>
            <c:dLbl>
              <c:idx val="11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5-C2A6-4871-90DC-67E2ED992F49}"/>
                </c:ext>
              </c:extLst>
            </c:dLbl>
            <c:dLbl>
              <c:idx val="12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6-C2A6-4871-90DC-67E2ED992F49}"/>
                </c:ext>
              </c:extLst>
            </c:dLbl>
            <c:dLbl>
              <c:idx val="13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7-C2A6-4871-90DC-67E2ED992F49}"/>
                </c:ext>
              </c:extLst>
            </c:dLbl>
            <c:dLbl>
              <c:idx val="14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8-C2A6-4871-90DC-67E2ED992F49}"/>
                </c:ext>
              </c:extLst>
            </c:dLbl>
            <c:dLbl>
              <c:idx val="15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9-C2A6-4871-90DC-67E2ED992F49}"/>
                </c:ext>
              </c:extLst>
            </c:dLbl>
            <c:dLbl>
              <c:idx val="16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A-C2A6-4871-90DC-67E2ED992F49}"/>
                </c:ext>
              </c:extLst>
            </c:dLbl>
            <c:dLbl>
              <c:idx val="17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B-C2A6-4871-90DC-67E2ED992F49}"/>
                </c:ext>
              </c:extLst>
            </c:dLbl>
            <c:dLbl>
              <c:idx val="18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C-C2A6-4871-90DC-67E2ED992F4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fat'!$D$27:$D$45</c:f>
              <c:strCache>
                <c:ptCount val="19"/>
                <c:pt idx="0">
                  <c:v>Turkey meat</c:v>
                </c:pt>
                <c:pt idx="1">
                  <c:v>Duck meat </c:v>
                </c:pt>
                <c:pt idx="2">
                  <c:v>Hen egg, pan-fried</c:v>
                </c:pt>
                <c:pt idx="3">
                  <c:v>Chicken meat</c:v>
                </c:pt>
                <c:pt idx="4">
                  <c:v>Bratwurst (pork)</c:v>
                </c:pt>
                <c:pt idx="5">
                  <c:v>Hen egg</c:v>
                </c:pt>
                <c:pt idx="6">
                  <c:v>Firm/semi-hard cheese </c:v>
                </c:pt>
                <c:pt idx="7">
                  <c:v>Fine cooked sausage (e.g. Lyoner, Mortadella) </c:v>
                </c:pt>
                <c:pt idx="8">
                  <c:v>Pork meat</c:v>
                </c:pt>
                <c:pt idx="9">
                  <c:v>Liver sausage (pig, beef)</c:v>
                </c:pt>
                <c:pt idx="10">
                  <c:v>Cow milk, plain</c:v>
                </c:pt>
                <c:pt idx="11">
                  <c:v>Butter</c:v>
                </c:pt>
                <c:pt idx="12">
                  <c:v>Salami-type sausage (pork, beef)</c:v>
                </c:pt>
                <c:pt idx="13">
                  <c:v>Quark</c:v>
                </c:pt>
                <c:pt idx="14">
                  <c:v>Cream, plain</c:v>
                </c:pt>
                <c:pt idx="15">
                  <c:v>Yoghurt/yoghurt drink, cow milk, flavoured</c:v>
                </c:pt>
                <c:pt idx="16">
                  <c:v>Bovine meat</c:v>
                </c:pt>
                <c:pt idx="17">
                  <c:v>Flavoured milk</c:v>
                </c:pt>
                <c:pt idx="18">
                  <c:v>Yoghurt, cow milk, plain</c:v>
                </c:pt>
              </c:strCache>
            </c:strRef>
          </c:cat>
          <c:val>
            <c:numRef>
              <c:f>'c vs o fat'!$E$27:$E$45</c:f>
              <c:numCache>
                <c:formatCode>0.000</c:formatCode>
                <c:ptCount val="19"/>
                <c:pt idx="0">
                  <c:v>0.41</c:v>
                </c:pt>
                <c:pt idx="1">
                  <c:v>0.79</c:v>
                </c:pt>
                <c:pt idx="2">
                  <c:v>0.50650000000000006</c:v>
                </c:pt>
                <c:pt idx="3">
                  <c:v>0.56000000000000005</c:v>
                </c:pt>
                <c:pt idx="4">
                  <c:v>0.87</c:v>
                </c:pt>
                <c:pt idx="5">
                  <c:v>0.83299999999999996</c:v>
                </c:pt>
                <c:pt idx="6">
                  <c:v>1.1776200000000001</c:v>
                </c:pt>
                <c:pt idx="7">
                  <c:v>1.39</c:v>
                </c:pt>
                <c:pt idx="8">
                  <c:v>1.4</c:v>
                </c:pt>
                <c:pt idx="9">
                  <c:v>1.8472250000000001</c:v>
                </c:pt>
                <c:pt idx="10">
                  <c:v>1.2800500000000001</c:v>
                </c:pt>
                <c:pt idx="11">
                  <c:v>1.40825</c:v>
                </c:pt>
                <c:pt idx="12">
                  <c:v>2.67</c:v>
                </c:pt>
                <c:pt idx="13">
                  <c:v>1.6400000000000001</c:v>
                </c:pt>
                <c:pt idx="14">
                  <c:v>1.7668750000000002</c:v>
                </c:pt>
                <c:pt idx="15">
                  <c:v>2.4299999999999997</c:v>
                </c:pt>
                <c:pt idx="16">
                  <c:v>2.380925</c:v>
                </c:pt>
                <c:pt idx="17">
                  <c:v>2.1557499999999998</c:v>
                </c:pt>
                <c:pt idx="18">
                  <c:v>3.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C2A6-4871-90DC-67E2ED992F49}"/>
            </c:ext>
          </c:extLst>
        </c:ser>
        <c:ser>
          <c:idx val="1"/>
          <c:order val="1"/>
          <c:tx>
            <c:strRef>
              <c:f>'c vs o fat'!$F$26</c:f>
              <c:strCache>
                <c:ptCount val="1"/>
                <c:pt idx="0">
                  <c:v>Conventiona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9"/>
              <c:numFmt formatCode="#,##0.0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E-C2A6-4871-90DC-67E2ED992F49}"/>
                </c:ext>
              </c:extLst>
            </c:dLbl>
            <c:dLbl>
              <c:idx val="10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F-C2A6-4871-90DC-67E2ED992F49}"/>
                </c:ext>
              </c:extLst>
            </c:dLbl>
            <c:dLbl>
              <c:idx val="11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0-C2A6-4871-90DC-67E2ED992F49}"/>
                </c:ext>
              </c:extLst>
            </c:dLbl>
            <c:dLbl>
              <c:idx val="13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1-C2A6-4871-90DC-67E2ED992F49}"/>
                </c:ext>
              </c:extLst>
            </c:dLbl>
            <c:dLbl>
              <c:idx val="14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2-C2A6-4871-90DC-67E2ED992F49}"/>
                </c:ext>
              </c:extLst>
            </c:dLbl>
            <c:dLbl>
              <c:idx val="15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3-C2A6-4871-90DC-67E2ED992F49}"/>
                </c:ext>
              </c:extLst>
            </c:dLbl>
            <c:dLbl>
              <c:idx val="16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4-C2A6-4871-90DC-67E2ED992F49}"/>
                </c:ext>
              </c:extLst>
            </c:dLbl>
            <c:dLbl>
              <c:idx val="17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5-C2A6-4871-90DC-67E2ED992F49}"/>
                </c:ext>
              </c:extLst>
            </c:dLbl>
            <c:dLbl>
              <c:idx val="18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6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6-C2A6-4871-90DC-67E2ED992F4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fat'!$D$27:$D$45</c:f>
              <c:strCache>
                <c:ptCount val="19"/>
                <c:pt idx="0">
                  <c:v>Turkey meat</c:v>
                </c:pt>
                <c:pt idx="1">
                  <c:v>Duck meat </c:v>
                </c:pt>
                <c:pt idx="2">
                  <c:v>Hen egg, pan-fried</c:v>
                </c:pt>
                <c:pt idx="3">
                  <c:v>Chicken meat</c:v>
                </c:pt>
                <c:pt idx="4">
                  <c:v>Bratwurst (pork)</c:v>
                </c:pt>
                <c:pt idx="5">
                  <c:v>Hen egg</c:v>
                </c:pt>
                <c:pt idx="6">
                  <c:v>Firm/semi-hard cheese </c:v>
                </c:pt>
                <c:pt idx="7">
                  <c:v>Fine cooked sausage (e.g. Lyoner, Mortadella) </c:v>
                </c:pt>
                <c:pt idx="8">
                  <c:v>Pork meat</c:v>
                </c:pt>
                <c:pt idx="9">
                  <c:v>Liver sausage (pig, beef)</c:v>
                </c:pt>
                <c:pt idx="10">
                  <c:v>Cow milk, plain</c:v>
                </c:pt>
                <c:pt idx="11">
                  <c:v>Butter</c:v>
                </c:pt>
                <c:pt idx="12">
                  <c:v>Salami-type sausage (pork, beef)</c:v>
                </c:pt>
                <c:pt idx="13">
                  <c:v>Quark</c:v>
                </c:pt>
                <c:pt idx="14">
                  <c:v>Cream, plain</c:v>
                </c:pt>
                <c:pt idx="15">
                  <c:v>Yoghurt/yoghurt drink, cow milk, flavoured</c:v>
                </c:pt>
                <c:pt idx="16">
                  <c:v>Bovine meat</c:v>
                </c:pt>
                <c:pt idx="17">
                  <c:v>Flavoured milk</c:v>
                </c:pt>
                <c:pt idx="18">
                  <c:v>Yoghurt, cow milk, plain</c:v>
                </c:pt>
              </c:strCache>
            </c:strRef>
          </c:cat>
          <c:val>
            <c:numRef>
              <c:f>'c vs o fat'!$F$27:$F$45</c:f>
              <c:numCache>
                <c:formatCode>0.000</c:formatCode>
                <c:ptCount val="19"/>
                <c:pt idx="0">
                  <c:v>0.38800000000000001</c:v>
                </c:pt>
                <c:pt idx="1">
                  <c:v>0.23100000000000001</c:v>
                </c:pt>
                <c:pt idx="2">
                  <c:v>0.53826249999999998</c:v>
                </c:pt>
                <c:pt idx="3">
                  <c:v>0.55499999999999994</c:v>
                </c:pt>
                <c:pt idx="4">
                  <c:v>0.30649999999999999</c:v>
                </c:pt>
                <c:pt idx="5">
                  <c:v>0.55754999999999999</c:v>
                </c:pt>
                <c:pt idx="6">
                  <c:v>0.43847999999999998</c:v>
                </c:pt>
                <c:pt idx="7">
                  <c:v>0.51829999999999998</c:v>
                </c:pt>
                <c:pt idx="8">
                  <c:v>0.88750000000000007</c:v>
                </c:pt>
                <c:pt idx="9">
                  <c:v>0.45450000000000002</c:v>
                </c:pt>
                <c:pt idx="10">
                  <c:v>1.0843</c:v>
                </c:pt>
                <c:pt idx="11">
                  <c:v>1.2588999999999999</c:v>
                </c:pt>
                <c:pt idx="12">
                  <c:v>0.44</c:v>
                </c:pt>
                <c:pt idx="13">
                  <c:v>1.55</c:v>
                </c:pt>
                <c:pt idx="14">
                  <c:v>2.0649999999999999</c:v>
                </c:pt>
                <c:pt idx="15">
                  <c:v>1.42</c:v>
                </c:pt>
                <c:pt idx="16">
                  <c:v>1.6870687499999999</c:v>
                </c:pt>
                <c:pt idx="17">
                  <c:v>2.1429999999999998</c:v>
                </c:pt>
                <c:pt idx="18">
                  <c:v>1.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C2A6-4871-90DC-67E2ED992F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80712272"/>
        <c:axId val="680716864"/>
      </c:barChart>
      <c:catAx>
        <c:axId val="680712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6864"/>
        <c:crosses val="autoZero"/>
        <c:auto val="1"/>
        <c:lblAlgn val="ctr"/>
        <c:lblOffset val="100"/>
        <c:noMultiLvlLbl val="0"/>
      </c:catAx>
      <c:valAx>
        <c:axId val="6807168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UB 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vels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∑6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DL-PCBs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g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</a:t>
                </a:r>
                <a:r>
                  <a:rPr lang="de-DE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t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de-DE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536485790457362"/>
              <c:y val="0.953483230840318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2272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c vs o fat'!$E$63</c:f>
              <c:strCache>
                <c:ptCount val="1"/>
                <c:pt idx="0">
                  <c:v>Organic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0-6D4C-4866-BFC6-E60ED4E017EE}"/>
                </c:ext>
              </c:extLst>
            </c:dLbl>
            <c:dLbl>
              <c:idx val="2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6D4C-4866-BFC6-E60ED4E017EE}"/>
                </c:ext>
              </c:extLst>
            </c:dLbl>
            <c:dLbl>
              <c:idx val="3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2-6D4C-4866-BFC6-E60ED4E017E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fat'!$D$64:$D$67</c:f>
              <c:strCache>
                <c:ptCount val="4"/>
                <c:pt idx="0">
                  <c:v>Animal and vegetable fats and oils (butter)</c:v>
                </c:pt>
                <c:pt idx="1">
                  <c:v>Eggs and egg products, n=2</c:v>
                </c:pt>
                <c:pt idx="2">
                  <c:v>Milk and dairy products, n=7</c:v>
                </c:pt>
                <c:pt idx="3">
                  <c:v>Meat and meat products, n=9</c:v>
                </c:pt>
              </c:strCache>
            </c:strRef>
          </c:cat>
          <c:val>
            <c:numRef>
              <c:f>'c vs o fat'!$E$64:$E$67</c:f>
              <c:numCache>
                <c:formatCode>0.000</c:formatCode>
                <c:ptCount val="4"/>
                <c:pt idx="0">
                  <c:v>1.40825</c:v>
                </c:pt>
                <c:pt idx="1">
                  <c:v>0.66975000000000007</c:v>
                </c:pt>
                <c:pt idx="2">
                  <c:v>1.9414707142857144</c:v>
                </c:pt>
                <c:pt idx="3">
                  <c:v>1.36868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D4C-4866-BFC6-E60ED4E017EE}"/>
            </c:ext>
          </c:extLst>
        </c:ser>
        <c:ser>
          <c:idx val="1"/>
          <c:order val="1"/>
          <c:tx>
            <c:strRef>
              <c:f>'c vs o fat'!$F$63</c:f>
              <c:strCache>
                <c:ptCount val="1"/>
                <c:pt idx="0">
                  <c:v>Conventiona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4-6D4C-4866-BFC6-E60ED4E017EE}"/>
                </c:ext>
              </c:extLst>
            </c:dLbl>
            <c:dLbl>
              <c:idx val="2"/>
              <c:numFmt formatCode="#,##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5-6D4C-4866-BFC6-E60ED4E017EE}"/>
                </c:ext>
              </c:extLst>
            </c:dLbl>
            <c:dLbl>
              <c:idx val="9"/>
              <c:numFmt formatCode="#,##0.0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6-6D4C-4866-BFC6-E60ED4E017E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fat'!$D$64:$D$67</c:f>
              <c:strCache>
                <c:ptCount val="4"/>
                <c:pt idx="0">
                  <c:v>Animal and vegetable fats and oils (butter)</c:v>
                </c:pt>
                <c:pt idx="1">
                  <c:v>Eggs and egg products, n=2</c:v>
                </c:pt>
                <c:pt idx="2">
                  <c:v>Milk and dairy products, n=7</c:v>
                </c:pt>
                <c:pt idx="3">
                  <c:v>Meat and meat products, n=9</c:v>
                </c:pt>
              </c:strCache>
            </c:strRef>
          </c:cat>
          <c:val>
            <c:numRef>
              <c:f>'c vs o fat'!$F$64:$F$67</c:f>
              <c:numCache>
                <c:formatCode>0.000</c:formatCode>
                <c:ptCount val="4"/>
                <c:pt idx="0">
                  <c:v>1.2588999999999999</c:v>
                </c:pt>
                <c:pt idx="1">
                  <c:v>0.54790625000000004</c:v>
                </c:pt>
                <c:pt idx="2">
                  <c:v>1.5243971428571428</c:v>
                </c:pt>
                <c:pt idx="3">
                  <c:v>0.607540972222222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D4C-4866-BFC6-E60ED4E017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80712272"/>
        <c:axId val="680716864"/>
      </c:barChart>
      <c:catAx>
        <c:axId val="680712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6864"/>
        <c:crosses val="autoZero"/>
        <c:auto val="1"/>
        <c:lblAlgn val="ctr"/>
        <c:lblOffset val="100"/>
        <c:noMultiLvlLbl val="0"/>
      </c:catAx>
      <c:valAx>
        <c:axId val="6807168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UB 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vels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∑6 NDL-PCBs (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g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</a:t>
                </a:r>
                <a:r>
                  <a:rPr lang="de-DE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t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de-DE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55678225525348801"/>
              <c:y val="0.8089805836257772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2272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6359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9074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9247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448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1054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2010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5296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0793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5743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0340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7826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D168B1-FB02-47B8-9C94-9AA503A8EC79}" type="datetimeFigureOut">
              <a:rPr lang="de-DE" smtClean="0"/>
              <a:t>31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4464B-EBDE-4C0B-A34D-32EC7FCC69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3257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643463" y="6366520"/>
            <a:ext cx="1131340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: Mean upper bound levels of the sum of six NDL-PCBs in MEAL food groups according to conventional and organic type of production based on the wet weight in (A) and on the </a:t>
            </a:r>
            <a:r>
              <a:rPr lang="en-US" sz="11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t content in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. (C) Comparison of foods of animal origin by the type of production. </a:t>
            </a:r>
            <a:r>
              <a:rPr lang="en-US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cudes liver samples. Data are means 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reflects the number of MEAL foods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2735752"/>
              </p:ext>
            </p:extLst>
          </p:nvPr>
        </p:nvGraphicFramePr>
        <p:xfrm>
          <a:off x="660037" y="217712"/>
          <a:ext cx="6002381" cy="47570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4508336"/>
              </p:ext>
            </p:extLst>
          </p:nvPr>
        </p:nvGraphicFramePr>
        <p:xfrm>
          <a:off x="6582095" y="217712"/>
          <a:ext cx="4564503" cy="62241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538955" y="69661"/>
            <a:ext cx="592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6490340" y="75503"/>
            <a:ext cx="592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7" name="Diagramm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1549568"/>
              </p:ext>
            </p:extLst>
          </p:nvPr>
        </p:nvGraphicFramePr>
        <p:xfrm>
          <a:off x="1252220" y="4899415"/>
          <a:ext cx="4584478" cy="1542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538955" y="4666993"/>
            <a:ext cx="592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3006272" y="1716793"/>
            <a:ext cx="2854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629689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4</Words>
  <Application>Microsoft Office PowerPoint</Application>
  <PresentationFormat>Breitbild</PresentationFormat>
  <Paragraphs>3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Bundesinstitut für Risikobewertu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u Dr. Mandy Stadion</dc:creator>
  <cp:lastModifiedBy>Frau Dr. Mandy Stadion</cp:lastModifiedBy>
  <cp:revision>24</cp:revision>
  <dcterms:created xsi:type="dcterms:W3CDTF">2023-04-17T12:37:48Z</dcterms:created>
  <dcterms:modified xsi:type="dcterms:W3CDTF">2024-01-31T10:27:45Z</dcterms:modified>
</cp:coreProperties>
</file>